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7561263" cy="5670550"/>
  <p:notesSz cx="7559675" cy="10691813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2" d="100"/>
          <a:sy n="112" d="100"/>
        </p:scale>
        <p:origin x="84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8040" y="226080"/>
            <a:ext cx="6804445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78040" y="1326600"/>
            <a:ext cx="6804445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78040" y="3044160"/>
            <a:ext cx="6804445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8040" y="226080"/>
            <a:ext cx="6804445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378040" y="1326600"/>
            <a:ext cx="3320539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864916" y="1326600"/>
            <a:ext cx="3320539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378040" y="3044160"/>
            <a:ext cx="3320539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3864916" y="3044160"/>
            <a:ext cx="3320539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8040" y="226080"/>
            <a:ext cx="6804445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378040" y="1326600"/>
            <a:ext cx="219074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2678681" y="1326600"/>
            <a:ext cx="219074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4979053" y="1326600"/>
            <a:ext cx="219074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378040" y="3044160"/>
            <a:ext cx="219074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2678681" y="3044160"/>
            <a:ext cx="219074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4979053" y="3044160"/>
            <a:ext cx="219074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8040" y="226080"/>
            <a:ext cx="6804445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8040" y="1326600"/>
            <a:ext cx="6804445" cy="32882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8040" y="226080"/>
            <a:ext cx="6804445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378040" y="1326600"/>
            <a:ext cx="6804445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8040" y="226080"/>
            <a:ext cx="6804445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378040" y="1326600"/>
            <a:ext cx="3320539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3864916" y="1326600"/>
            <a:ext cx="3320539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8040" y="226080"/>
            <a:ext cx="6804445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8040" y="226080"/>
            <a:ext cx="6804445" cy="43884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8040" y="226080"/>
            <a:ext cx="6804445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378040" y="1326600"/>
            <a:ext cx="3320539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3864916" y="1326600"/>
            <a:ext cx="3320539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378040" y="3044160"/>
            <a:ext cx="3320539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8040" y="226080"/>
            <a:ext cx="6804445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378040" y="1326600"/>
            <a:ext cx="3320539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3864916" y="1326600"/>
            <a:ext cx="3320539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3864916" y="3044160"/>
            <a:ext cx="3320539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8040" y="226080"/>
            <a:ext cx="6804445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378040" y="1326600"/>
            <a:ext cx="3320539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3864916" y="1326600"/>
            <a:ext cx="3320539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378040" y="3044160"/>
            <a:ext cx="6804445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8040" y="226080"/>
            <a:ext cx="6804445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r>
              <a:rPr lang="en-US" sz="4400" b="0" strike="noStrike" spc="-1">
                <a:latin typeface="Arial"/>
              </a:rPr>
              <a:t>Click to edit the title text format</a:t>
            </a: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378040" y="1326600"/>
            <a:ext cx="6804445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3200" b="0" strike="noStrike" spc="-1"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800" b="0" strike="noStrike" spc="-1"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400" b="0" strike="noStrike" spc="-1"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000" b="0" strike="noStrike" spc="-1"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eventh Outline Level</a:t>
            </a:r>
          </a:p>
        </p:txBody>
      </p:sp>
      <p:sp>
        <p:nvSpPr>
          <p:cNvPr id="2" name="PlaceHolder 3"/>
          <p:cNvSpPr>
            <a:spLocks noGrp="1"/>
          </p:cNvSpPr>
          <p:nvPr>
            <p:ph type="dt"/>
          </p:nvPr>
        </p:nvSpPr>
        <p:spPr>
          <a:xfrm>
            <a:off x="378040" y="5165280"/>
            <a:ext cx="1761395" cy="390600"/>
          </a:xfrm>
          <a:prstGeom prst="rect">
            <a:avLst/>
          </a:prstGeom>
        </p:spPr>
        <p:txBody>
          <a:bodyPr lIns="0" tIns="0" rIns="0" bIns="0"/>
          <a:lstStyle/>
          <a:p>
            <a:r>
              <a:rPr lang="en-US" sz="1400" b="0" strike="noStrike" spc="-1">
                <a:latin typeface="Times New Roman"/>
              </a:rPr>
              <a:t>&lt;date/time&gt;</a:t>
            </a:r>
          </a:p>
        </p:txBody>
      </p:sp>
      <p:sp>
        <p:nvSpPr>
          <p:cNvPr id="3" name="PlaceHolder 4"/>
          <p:cNvSpPr>
            <a:spLocks noGrp="1"/>
          </p:cNvSpPr>
          <p:nvPr>
            <p:ph type="ftr"/>
          </p:nvPr>
        </p:nvSpPr>
        <p:spPr>
          <a:xfrm>
            <a:off x="2585791" y="5165280"/>
            <a:ext cx="2396502" cy="390600"/>
          </a:xfrm>
          <a:prstGeom prst="rect">
            <a:avLst/>
          </a:prstGeom>
        </p:spPr>
        <p:txBody>
          <a:bodyPr lIns="0" tIns="0" rIns="0" bIns="0"/>
          <a:lstStyle/>
          <a:p>
            <a:pPr algn="ctr"/>
            <a:r>
              <a:rPr lang="en-US" sz="1400" b="0" strike="noStrike" spc="-1">
                <a:latin typeface="Times New Roman"/>
              </a:rPr>
              <a:t>&lt;footer&gt;</a:t>
            </a:r>
          </a:p>
        </p:txBody>
      </p:sp>
      <p:sp>
        <p:nvSpPr>
          <p:cNvPr id="4" name="PlaceHolder 5"/>
          <p:cNvSpPr>
            <a:spLocks noGrp="1"/>
          </p:cNvSpPr>
          <p:nvPr>
            <p:ph type="sldNum"/>
          </p:nvPr>
        </p:nvSpPr>
        <p:spPr>
          <a:xfrm>
            <a:off x="5421089" y="5165280"/>
            <a:ext cx="1761395" cy="390600"/>
          </a:xfrm>
          <a:prstGeom prst="rect">
            <a:avLst/>
          </a:prstGeom>
        </p:spPr>
        <p:txBody>
          <a:bodyPr lIns="0" tIns="0" rIns="0" bIns="0"/>
          <a:lstStyle/>
          <a:p>
            <a:pPr algn="r"/>
            <a:fld id="{DEFDFFEB-81B5-47D1-A9AC-4293C51EC3E7}" type="slidenum">
              <a:rPr lang="en-US" sz="1400" b="0" strike="noStrike" spc="-1">
                <a:latin typeface="Times New Roman"/>
              </a:rPr>
              <a:t>‹#›</a:t>
            </a:fld>
            <a:endParaRPr lang="en-US" sz="1400" b="0" strike="noStrike" spc="-1">
              <a:latin typeface="Times New Roman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32000" indent="-324000" algn="l" defTabSz="914400" rtl="0" eaLnBrk="1" latinLnBrk="0" hangingPunct="1">
        <a:lnSpc>
          <a:spcPct val="90000"/>
        </a:lnSpc>
        <a:spcBef>
          <a:spcPts val="1417"/>
        </a:spcBef>
        <a:buClr>
          <a:srgbClr val="000000"/>
        </a:buClr>
        <a:buSzPct val="45000"/>
        <a:buFont typeface="Wingdings" charset="2"/>
        <a:buChar char="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Рисунок 40"/>
          <p:cNvPicPr/>
          <p:nvPr/>
        </p:nvPicPr>
        <p:blipFill>
          <a:blip r:embed="rId2"/>
          <a:stretch/>
        </p:blipFill>
        <p:spPr>
          <a:xfrm>
            <a:off x="924624" y="79079"/>
            <a:ext cx="5486400" cy="4888080"/>
          </a:xfrm>
          <a:prstGeom prst="rect">
            <a:avLst/>
          </a:prstGeom>
          <a:ln>
            <a:noFill/>
          </a:ln>
        </p:spPr>
      </p:pic>
      <p:sp>
        <p:nvSpPr>
          <p:cNvPr id="42" name="TextShape 1"/>
          <p:cNvSpPr txBox="1"/>
          <p:nvPr/>
        </p:nvSpPr>
        <p:spPr>
          <a:xfrm>
            <a:off x="1320379" y="5103677"/>
            <a:ext cx="5312484" cy="48996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r>
              <a:rPr lang="en-US" sz="1200" b="1" spc="-1" dirty="0">
                <a:latin typeface="Palatino Linotype" panose="02040502050505030304" pitchFamily="18" charset="0"/>
              </a:rPr>
              <a:t>Supplementary Figure </a:t>
            </a:r>
            <a:r>
              <a:rPr lang="en-US" sz="1200" b="1" spc="-1" dirty="0" smtClean="0">
                <a:latin typeface="Palatino Linotype" panose="02040502050505030304" pitchFamily="18" charset="0"/>
              </a:rPr>
              <a:t>S1. </a:t>
            </a:r>
            <a:r>
              <a:rPr lang="en-US" sz="1200" spc="-1" dirty="0">
                <a:latin typeface="Palatino Linotype" panose="02040502050505030304" pitchFamily="18" charset="0"/>
              </a:rPr>
              <a:t>The PCA plot showing the overall transcriptional response of 20 individual studies exposed by TCDD</a:t>
            </a:r>
            <a:r>
              <a:rPr lang="ru-RU" sz="1200" spc="-1" dirty="0">
                <a:latin typeface="Palatino Linotype" panose="02040502050505030304" pitchFamily="18" charset="0"/>
              </a:rPr>
              <a:t>.</a:t>
            </a:r>
            <a:endParaRPr lang="en-US" sz="1200" spc="-1" dirty="0">
              <a:latin typeface="Palatino Linotype" panose="0204050205050503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</TotalTime>
  <Words>20</Words>
  <Application>Microsoft Office PowerPoint</Application>
  <PresentationFormat>Произвольный</PresentationFormat>
  <Paragraphs>1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6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8" baseType="lpstr">
      <vt:lpstr>Arial</vt:lpstr>
      <vt:lpstr>DejaVu Sans</vt:lpstr>
      <vt:lpstr>Palatino Linotype</vt:lpstr>
      <vt:lpstr>Symbol</vt:lpstr>
      <vt:lpstr>Times New Roman</vt:lpstr>
      <vt:lpstr>Wingdings</vt:lpstr>
      <vt:lpstr>Office Theme</vt:lpstr>
      <vt:lpstr>Презентация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subject/>
  <dc:creator>OshchepkovaEA</dc:creator>
  <dc:description/>
  <cp:lastModifiedBy>Ощепкова Евгения Александровна</cp:lastModifiedBy>
  <cp:revision>4</cp:revision>
  <dcterms:created xsi:type="dcterms:W3CDTF">2020-10-16T16:50:01Z</dcterms:created>
  <dcterms:modified xsi:type="dcterms:W3CDTF">2020-10-17T04:50:21Z</dcterms:modified>
  <dc:language>en-US</dc:language>
</cp:coreProperties>
</file>